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43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723" autoAdjust="0"/>
    <p:restoredTop sz="88632" autoAdjust="0"/>
  </p:normalViewPr>
  <p:slideViewPr>
    <p:cSldViewPr snapToGrid="0" snapToObjects="1">
      <p:cViewPr>
        <p:scale>
          <a:sx n="70" d="100"/>
          <a:sy n="70" d="100"/>
        </p:scale>
        <p:origin x="-2292" y="10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1B3F9F-F21E-493F-BFEA-F1D2D09CFAD3}" type="datetimeFigureOut">
              <a:rPr lang="en-CA" smtClean="0"/>
              <a:pPr/>
              <a:t>22/05/2015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345854-6294-413A-9C21-02DA63F77C4A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515077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345854-6294-413A-9C21-02DA63F77C4A}" type="slidenum">
              <a:rPr lang="en-CA" smtClean="0"/>
              <a:pPr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282259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949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657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789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260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921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430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4862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6742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614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702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793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0677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tiff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png"/><Relationship Id="rId11" Type="http://schemas.openxmlformats.org/officeDocument/2006/relationships/image" Target="../media/image9.tiff"/><Relationship Id="rId5" Type="http://schemas.openxmlformats.org/officeDocument/2006/relationships/image" Target="../media/image3.png"/><Relationship Id="rId10" Type="http://schemas.openxmlformats.org/officeDocument/2006/relationships/image" Target="../media/image8.tiff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3" name="Picture 3" descr="C:\Users\Euan\Desktop\Euan's LAB NEW\Manuscripts\CAT EAE Manuscript\CAT BSL Paper\Prizm FIles\High Res pannels\S7 b rmog dose other inhibitors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51576" y="391659"/>
            <a:ext cx="3026664" cy="17282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4" name="Group 3"/>
          <p:cNvGrpSpPr/>
          <p:nvPr/>
        </p:nvGrpSpPr>
        <p:grpSpPr>
          <a:xfrm>
            <a:off x="635130" y="2192131"/>
            <a:ext cx="2628585" cy="2845807"/>
            <a:chOff x="1728392" y="5071260"/>
            <a:chExt cx="2628585" cy="2845807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188867" y="6708397"/>
              <a:ext cx="687600" cy="687600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866942" y="6708397"/>
              <a:ext cx="687600" cy="68760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180040" y="6020797"/>
              <a:ext cx="687600" cy="687600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866942" y="6020797"/>
              <a:ext cx="687600" cy="687600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188867" y="5325690"/>
              <a:ext cx="687600" cy="687600"/>
            </a:xfrm>
            <a:prstGeom prst="rect">
              <a:avLst/>
            </a:prstGeom>
          </p:spPr>
        </p:pic>
        <p:pic>
          <p:nvPicPr>
            <p:cNvPr id="13" name="Picture 12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867640" y="5333197"/>
              <a:ext cx="687600" cy="687600"/>
            </a:xfrm>
            <a:prstGeom prst="rect">
              <a:avLst/>
            </a:prstGeom>
          </p:spPr>
        </p:pic>
        <p:sp>
          <p:nvSpPr>
            <p:cNvPr id="21" name="TextBox 20"/>
            <p:cNvSpPr txBox="1"/>
            <p:nvPr/>
          </p:nvSpPr>
          <p:spPr>
            <a:xfrm>
              <a:off x="1948084" y="7370112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183312" y="7372372"/>
              <a:ext cx="5059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355462" y="7371111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516599" y="7368731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675182" y="7368505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944473" y="7142680"/>
              <a:ext cx="5059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948084" y="6977733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943905" y="6809984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947436" y="6644076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0" name="Group 51"/>
            <p:cNvGrpSpPr/>
            <p:nvPr/>
          </p:nvGrpSpPr>
          <p:grpSpPr>
            <a:xfrm>
              <a:off x="1958220" y="7213646"/>
              <a:ext cx="457200" cy="457200"/>
              <a:chOff x="609590" y="2083234"/>
              <a:chExt cx="457200" cy="457200"/>
            </a:xfrm>
          </p:grpSpPr>
          <p:cxnSp>
            <p:nvCxnSpPr>
              <p:cNvPr id="41" name="Straight Arrow Connector 40"/>
              <p:cNvCxnSpPr/>
              <p:nvPr/>
            </p:nvCxnSpPr>
            <p:spPr>
              <a:xfrm>
                <a:off x="609590" y="2533650"/>
                <a:ext cx="457200" cy="158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Straight Arrow Connector 41"/>
              <p:cNvCxnSpPr/>
              <p:nvPr/>
            </p:nvCxnSpPr>
            <p:spPr>
              <a:xfrm rot="5400000" flipH="1" flipV="1">
                <a:off x="389284" y="2311040"/>
                <a:ext cx="457200" cy="158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1" name="TextBox 30"/>
            <p:cNvSpPr txBox="1"/>
            <p:nvPr/>
          </p:nvSpPr>
          <p:spPr>
            <a:xfrm>
              <a:off x="1884043" y="7670846"/>
              <a:ext cx="774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CD69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 rot="16200000">
              <a:off x="1464196" y="7171684"/>
              <a:ext cx="774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CD4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352032" y="5071261"/>
              <a:ext cx="774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NP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2867640" y="5071260"/>
              <a:ext cx="10725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MOG</a:t>
              </a:r>
              <a:r>
                <a:rPr lang="en-US" sz="1000" baseline="30000" dirty="0" smtClean="0">
                  <a:latin typeface="Arial" pitchFamily="34" charset="0"/>
                  <a:cs typeface="Arial" pitchFamily="34" charset="0"/>
                </a:rPr>
                <a:t>35-55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3582363" y="6894979"/>
              <a:ext cx="774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Untreated 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136309" y="6716138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81.7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2484752" y="6689045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2.06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157779" y="5998795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9.95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2449645" y="6004078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.92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3582363" y="6219522"/>
              <a:ext cx="774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E-64D 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3582363" y="5553886"/>
              <a:ext cx="774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err="1" smtClean="0">
                  <a:latin typeface="Arial" pitchFamily="34" charset="0"/>
                  <a:cs typeface="Arial" pitchFamily="34" charset="0"/>
                </a:rPr>
                <a:t>Leupeptin</a:t>
              </a:r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 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3135368" y="5317481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25.9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2440681" y="5322764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.63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50" name="TextBox 49"/>
          <p:cNvSpPr txBox="1"/>
          <p:nvPr/>
        </p:nvSpPr>
        <p:spPr>
          <a:xfrm>
            <a:off x="598635" y="5230337"/>
            <a:ext cx="5083608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7 Fig.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nhibition of cysteine cathepsins reduces MHC-II restricted presentation efficiencies of MOG antigens in BMMØ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WT BMMØ were treated overnight with DMSO vehicle (untreated), E-64d (10 µg/ml) an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Leupepti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2.5 µg/ml) and were subsequently incubated for 6 h with 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MOG</a:t>
            </a:r>
            <a:r>
              <a:rPr lang="en-CA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5-55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peptide (0, 10, 25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/ml) or MOG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1-125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0, 10, 25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/ml). Activation of 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MOG</a:t>
            </a:r>
            <a:r>
              <a:rPr lang="en-CA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5-55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specific 2D2 CD4+ T cells was determined by surface expression of CD69 after 16 h exposure to the pulsed and washed BMMØs.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epresentative flow cytometry plots of no peptide (NP), or 25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/ml MOG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5-55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 Percentage of live BMMØ (as evaluated by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rypa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blue exclusion) after 24 h exposure to E-64d (10 µg/ml) an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Leupepti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2.5 µg/ml).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 Data represent 3 independent experiment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. Data presented as mean +/- SEM (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ANOVA, p&lt;0.05); significant differences from internal WT controls are denoted by asterisks (*). </a:t>
            </a:r>
          </a:p>
          <a:p>
            <a:endParaRPr lang="en-CA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122" name="Picture 2" descr="C:\Users\Euan\Desktop\Euan's LAB NEW\Manuscripts\CAT EAE Manuscript\CAT BSL Paper\Prizm FIles\High Res pannels\S7 a peptide dose other inhibitors.tif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60" y="391659"/>
            <a:ext cx="3026664" cy="17282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24" name="Picture 4" descr="C:\Users\Euan\Desktop\Euan's LAB NEW\Manuscripts\CAT EAE Manuscript\CAT BSL Paper\Prizm FIles\High Res pannels\S7 D Trypan Blue e64 leupeptin.tif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3719" y="2487766"/>
            <a:ext cx="1944624" cy="16946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9235531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93</TotalTime>
  <Words>198</Words>
  <Application>Microsoft Office PowerPoint</Application>
  <PresentationFormat>On-screen Show (4:3)</PresentationFormat>
  <Paragraphs>2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Euan</cp:lastModifiedBy>
  <cp:revision>1550</cp:revision>
  <dcterms:created xsi:type="dcterms:W3CDTF">2012-09-11T17:14:12Z</dcterms:created>
  <dcterms:modified xsi:type="dcterms:W3CDTF">2015-05-22T19:08:42Z</dcterms:modified>
</cp:coreProperties>
</file>